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EA9F1-8C36-4979-B600-12C0D571A2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BA8E9-35D5-43A5-BD5B-74DE060467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3902F-4E74-4B5E-ACF9-F9EC02B23A1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14F112-5FC8-461C-8833-A17717D18C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7F165-A3BB-436E-8711-93B8B88355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06204-5486-44EF-969B-A5E91C79AE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FD7AA-46B6-4974-9C33-5437A3780E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213FF-FD31-4991-BE9F-1B881E0C77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580BB3-0609-4E82-8547-DE229EC4A1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5FA15-E84B-4951-ADA2-C7550B034E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FDB7F-8E16-4D73-8F46-34BD0582E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CFD58-A4BB-4AD7-A447-05FC9A0561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D32350-E70A-4B4D-BCEF-8631FCC3C52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2"/>
          <p:cNvSpPr/>
          <p:nvPr/>
        </p:nvSpPr>
        <p:spPr>
          <a:xfrm>
            <a:off x="385920" y="3746520"/>
            <a:ext cx="1252440" cy="1371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a, height of mutant wav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b, height of wild type wav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42"/>
          <p:cNvSpPr/>
          <p:nvPr/>
        </p:nvSpPr>
        <p:spPr>
          <a:xfrm>
            <a:off x="385920" y="5800680"/>
            <a:ext cx="8458200" cy="549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A%</a:t>
            </a:r>
            <a:r>
              <a:rPr b="1" lang="ja-JP" sz="1400" spc="-1" strike="noStrike">
                <a:solidFill>
                  <a:srgbClr val="000000"/>
                </a:solidFill>
                <a:latin typeface="Calibri"/>
                <a:ea typeface="Arial"/>
              </a:rPr>
              <a:t>　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= mean value of mutant proportion of first five waves with alteratio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Mean of [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/ (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+ B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1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), 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/ (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+ B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2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), 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3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/ (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3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+ B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3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), 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4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/ (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4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+ B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4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), 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5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/ (a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5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 + B</a:t>
            </a:r>
            <a:r>
              <a:rPr b="1" lang="en-US" sz="1400" spc="-1" strike="noStrike" baseline="-25000">
                <a:solidFill>
                  <a:srgbClr val="000000"/>
                </a:solidFill>
                <a:latin typeface="Calibri"/>
                <a:ea typeface="Arial"/>
              </a:rPr>
              <a:t>5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  <a:ea typeface="Arial"/>
              </a:rPr>
              <a:t>)] (%</a:t>
            </a:r>
            <a:r>
              <a:rPr b="1" lang="ja-JP" sz="1400" spc="-1" strike="noStrike">
                <a:solidFill>
                  <a:srgbClr val="000000"/>
                </a:solidFill>
                <a:latin typeface="Calibri"/>
                <a:ea typeface="Arial"/>
              </a:rPr>
              <a:t>）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グループ化 47"/>
          <p:cNvGrpSpPr/>
          <p:nvPr/>
        </p:nvGrpSpPr>
        <p:grpSpPr>
          <a:xfrm>
            <a:off x="1467000" y="900000"/>
            <a:ext cx="6305400" cy="1971720"/>
            <a:chOff x="1467000" y="900000"/>
            <a:chExt cx="6305400" cy="1971720"/>
          </a:xfrm>
        </p:grpSpPr>
        <p:pic>
          <p:nvPicPr>
            <p:cNvPr id="44" name="Picture 3" descr=""/>
            <p:cNvPicPr/>
            <p:nvPr/>
          </p:nvPicPr>
          <p:blipFill>
            <a:blip r:embed="rId1">
              <a:lum bright="10000"/>
            </a:blip>
            <a:stretch/>
          </p:blipFill>
          <p:spPr>
            <a:xfrm>
              <a:off x="1467000" y="900000"/>
              <a:ext cx="6305400" cy="1971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5" name="正方形/長方形 46"/>
            <p:cNvSpPr/>
            <p:nvPr/>
          </p:nvSpPr>
          <p:spPr>
            <a:xfrm>
              <a:off x="2071800" y="904680"/>
              <a:ext cx="314280" cy="452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46" name="直線矢印コネクタ 111"/>
          <p:cNvCxnSpPr/>
          <p:nvPr/>
        </p:nvCxnSpPr>
        <p:spPr>
          <a:xfrm flipV="1">
            <a:off x="2300400" y="1018800"/>
            <a:ext cx="5487120" cy="7200"/>
          </a:xfrm>
          <a:prstGeom prst="straightConnector1">
            <a:avLst/>
          </a:prstGeom>
          <a:ln w="38160">
            <a:solidFill>
              <a:srgbClr val="000000"/>
            </a:solidFill>
            <a:miter/>
            <a:tailEnd len="sm" type="arrow" w="sm"/>
          </a:ln>
        </p:spPr>
      </p:cxnSp>
      <p:sp>
        <p:nvSpPr>
          <p:cNvPr id="47" name="テキスト ボックス 29"/>
          <p:cNvSpPr/>
          <p:nvPr/>
        </p:nvSpPr>
        <p:spPr>
          <a:xfrm>
            <a:off x="1989000" y="765000"/>
            <a:ext cx="55584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直線コネクタ 113"/>
          <p:cNvSpPr/>
          <p:nvPr/>
        </p:nvSpPr>
        <p:spPr>
          <a:xfrm>
            <a:off x="2306520" y="1006560"/>
            <a:ext cx="0" cy="30636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グループ化 155"/>
          <p:cNvGrpSpPr/>
          <p:nvPr/>
        </p:nvGrpSpPr>
        <p:grpSpPr>
          <a:xfrm>
            <a:off x="5337000" y="3316320"/>
            <a:ext cx="938520" cy="2027160"/>
            <a:chOff x="5337000" y="3316320"/>
            <a:chExt cx="938520" cy="2027160"/>
          </a:xfrm>
        </p:grpSpPr>
        <p:pic>
          <p:nvPicPr>
            <p:cNvPr id="50" name="Picture 7" descr=""/>
            <p:cNvPicPr/>
            <p:nvPr/>
          </p:nvPicPr>
          <p:blipFill>
            <a:blip r:embed="rId2"/>
            <a:srcRect l="0" t="22371" r="0" b="0"/>
            <a:stretch/>
          </p:blipFill>
          <p:spPr>
            <a:xfrm>
              <a:off x="5895360" y="3316320"/>
              <a:ext cx="313200" cy="202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直線コネクタ 37"/>
            <p:cNvSpPr/>
            <p:nvPr/>
          </p:nvSpPr>
          <p:spPr>
            <a:xfrm flipV="1">
              <a:off x="5443560" y="3520080"/>
              <a:ext cx="567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テキスト ボックス 41"/>
            <p:cNvSpPr/>
            <p:nvPr/>
          </p:nvSpPr>
          <p:spPr>
            <a:xfrm>
              <a:off x="5524920" y="5011200"/>
              <a:ext cx="36180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3" name="直線矢印コネクタ 39"/>
            <p:cNvCxnSpPr/>
            <p:nvPr/>
          </p:nvCxnSpPr>
          <p:spPr>
            <a:xfrm flipH="1">
              <a:off x="5845320" y="5033880"/>
              <a:ext cx="5400" cy="2314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54" name="直線コネクタ 36"/>
            <p:cNvSpPr/>
            <p:nvPr/>
          </p:nvSpPr>
          <p:spPr>
            <a:xfrm flipV="1">
              <a:off x="5593680" y="5040360"/>
              <a:ext cx="48636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線コネクタ 35"/>
            <p:cNvSpPr/>
            <p:nvPr/>
          </p:nvSpPr>
          <p:spPr>
            <a:xfrm>
              <a:off x="5474520" y="5262840"/>
              <a:ext cx="43992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6" name="直線矢印コネクタ 38"/>
            <p:cNvCxnSpPr/>
            <p:nvPr/>
          </p:nvCxnSpPr>
          <p:spPr>
            <a:xfrm flipH="1">
              <a:off x="5535360" y="3519360"/>
              <a:ext cx="7920" cy="17532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57" name="テキスト ボックス 40"/>
            <p:cNvSpPr/>
            <p:nvPr/>
          </p:nvSpPr>
          <p:spPr>
            <a:xfrm>
              <a:off x="5337000" y="4154040"/>
              <a:ext cx="39996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正方形/長方形 146"/>
            <p:cNvSpPr/>
            <p:nvPr/>
          </p:nvSpPr>
          <p:spPr>
            <a:xfrm>
              <a:off x="5398920" y="3324240"/>
              <a:ext cx="876600" cy="2019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グループ化 156"/>
          <p:cNvGrpSpPr/>
          <p:nvPr/>
        </p:nvGrpSpPr>
        <p:grpSpPr>
          <a:xfrm>
            <a:off x="6518160" y="3316320"/>
            <a:ext cx="885960" cy="2027160"/>
            <a:chOff x="6518160" y="3316320"/>
            <a:chExt cx="885960" cy="2027160"/>
          </a:xfrm>
        </p:grpSpPr>
        <p:pic>
          <p:nvPicPr>
            <p:cNvPr id="60" name="Picture 8" descr=""/>
            <p:cNvPicPr/>
            <p:nvPr/>
          </p:nvPicPr>
          <p:blipFill>
            <a:blip r:embed="rId3"/>
            <a:srcRect l="0" t="22371" r="0" b="0"/>
            <a:stretch/>
          </p:blipFill>
          <p:spPr>
            <a:xfrm>
              <a:off x="7048800" y="3316320"/>
              <a:ext cx="261720" cy="202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直線コネクタ 35"/>
            <p:cNvSpPr/>
            <p:nvPr/>
          </p:nvSpPr>
          <p:spPr>
            <a:xfrm>
              <a:off x="6612840" y="5262840"/>
              <a:ext cx="44460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線コネクタ 36"/>
            <p:cNvSpPr/>
            <p:nvPr/>
          </p:nvSpPr>
          <p:spPr>
            <a:xfrm>
              <a:off x="6760440" y="4862520"/>
              <a:ext cx="42408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線コネクタ 37"/>
            <p:cNvSpPr/>
            <p:nvPr/>
          </p:nvSpPr>
          <p:spPr>
            <a:xfrm flipV="1">
              <a:off x="6591600" y="3682080"/>
              <a:ext cx="5572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テキスト ボックス 41"/>
            <p:cNvSpPr/>
            <p:nvPr/>
          </p:nvSpPr>
          <p:spPr>
            <a:xfrm>
              <a:off x="6665400" y="4911120"/>
              <a:ext cx="36180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5" name="直線矢印コネクタ 39"/>
            <p:cNvCxnSpPr/>
            <p:nvPr/>
          </p:nvCxnSpPr>
          <p:spPr>
            <a:xfrm flipH="1">
              <a:off x="6964200" y="4857480"/>
              <a:ext cx="1080" cy="401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66" name="直線矢印コネクタ 38"/>
            <p:cNvCxnSpPr/>
            <p:nvPr/>
          </p:nvCxnSpPr>
          <p:spPr>
            <a:xfrm flipH="1">
              <a:off x="6706800" y="3674160"/>
              <a:ext cx="1440" cy="1598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67" name="テキスト ボックス 40"/>
            <p:cNvSpPr/>
            <p:nvPr/>
          </p:nvSpPr>
          <p:spPr>
            <a:xfrm>
              <a:off x="6518160" y="4358880"/>
              <a:ext cx="39996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正方形/長方形 147"/>
            <p:cNvSpPr/>
            <p:nvPr/>
          </p:nvSpPr>
          <p:spPr>
            <a:xfrm>
              <a:off x="6527520" y="3324240"/>
              <a:ext cx="876600" cy="2019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9" name="グループ化 153"/>
          <p:cNvGrpSpPr/>
          <p:nvPr/>
        </p:nvGrpSpPr>
        <p:grpSpPr>
          <a:xfrm>
            <a:off x="3114720" y="3316320"/>
            <a:ext cx="907920" cy="2027160"/>
            <a:chOff x="3114720" y="3316320"/>
            <a:chExt cx="907920" cy="2027160"/>
          </a:xfrm>
        </p:grpSpPr>
        <p:pic>
          <p:nvPicPr>
            <p:cNvPr id="70" name="Picture 5" descr=""/>
            <p:cNvPicPr/>
            <p:nvPr/>
          </p:nvPicPr>
          <p:blipFill>
            <a:blip r:embed="rId4"/>
            <a:srcRect l="0" t="22371" r="0" b="0"/>
            <a:stretch/>
          </p:blipFill>
          <p:spPr>
            <a:xfrm>
              <a:off x="3700800" y="3316320"/>
              <a:ext cx="261720" cy="202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1" name="直線コネクタ 35"/>
            <p:cNvSpPr/>
            <p:nvPr/>
          </p:nvSpPr>
          <p:spPr>
            <a:xfrm>
              <a:off x="3224160" y="5262840"/>
              <a:ext cx="48492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線コネクタ 36"/>
            <p:cNvSpPr/>
            <p:nvPr/>
          </p:nvSpPr>
          <p:spPr>
            <a:xfrm>
              <a:off x="3367080" y="4896000"/>
              <a:ext cx="43596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直線コネクタ 37"/>
            <p:cNvSpPr/>
            <p:nvPr/>
          </p:nvSpPr>
          <p:spPr>
            <a:xfrm>
              <a:off x="3205080" y="3767040"/>
              <a:ext cx="59544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テキスト ボックス 41"/>
            <p:cNvSpPr/>
            <p:nvPr/>
          </p:nvSpPr>
          <p:spPr>
            <a:xfrm>
              <a:off x="3286080" y="4930200"/>
              <a:ext cx="36180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5" name="直線矢印コネクタ 39"/>
            <p:cNvCxnSpPr/>
            <p:nvPr/>
          </p:nvCxnSpPr>
          <p:spPr>
            <a:xfrm flipH="1">
              <a:off x="3594960" y="4895640"/>
              <a:ext cx="5760" cy="3632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76" name="直線矢印コネクタ 38"/>
            <p:cNvCxnSpPr/>
            <p:nvPr/>
          </p:nvCxnSpPr>
          <p:spPr>
            <a:xfrm flipH="1">
              <a:off x="3318120" y="3762360"/>
              <a:ext cx="6480" cy="15105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77" name="テキスト ボックス 40"/>
            <p:cNvSpPr/>
            <p:nvPr/>
          </p:nvSpPr>
          <p:spPr>
            <a:xfrm>
              <a:off x="3114720" y="4377960"/>
              <a:ext cx="39996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正方形/長方形 149"/>
            <p:cNvSpPr/>
            <p:nvPr/>
          </p:nvSpPr>
          <p:spPr>
            <a:xfrm>
              <a:off x="3146400" y="3324240"/>
              <a:ext cx="876240" cy="2019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グループ化 154"/>
          <p:cNvGrpSpPr/>
          <p:nvPr/>
        </p:nvGrpSpPr>
        <p:grpSpPr>
          <a:xfrm>
            <a:off x="4233960" y="3316320"/>
            <a:ext cx="884160" cy="2027160"/>
            <a:chOff x="4233960" y="3316320"/>
            <a:chExt cx="884160" cy="2027160"/>
          </a:xfrm>
        </p:grpSpPr>
        <p:pic>
          <p:nvPicPr>
            <p:cNvPr id="80" name="Picture 6" descr=""/>
            <p:cNvPicPr/>
            <p:nvPr/>
          </p:nvPicPr>
          <p:blipFill>
            <a:blip r:embed="rId5"/>
            <a:srcRect l="0" t="22371" r="0" b="0"/>
            <a:stretch/>
          </p:blipFill>
          <p:spPr>
            <a:xfrm>
              <a:off x="4803120" y="3316320"/>
              <a:ext cx="251640" cy="202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直線コネクタ 37"/>
            <p:cNvSpPr/>
            <p:nvPr/>
          </p:nvSpPr>
          <p:spPr>
            <a:xfrm>
              <a:off x="4340880" y="3900600"/>
              <a:ext cx="55044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テキスト ボックス 41"/>
            <p:cNvSpPr/>
            <p:nvPr/>
          </p:nvSpPr>
          <p:spPr>
            <a:xfrm>
              <a:off x="4405320" y="5025240"/>
              <a:ext cx="36180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3" name="直線矢印コネクタ 39"/>
            <p:cNvCxnSpPr/>
            <p:nvPr/>
          </p:nvCxnSpPr>
          <p:spPr>
            <a:xfrm flipH="1">
              <a:off x="4725720" y="5076720"/>
              <a:ext cx="1080" cy="1868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84" name="直線コネクタ 35"/>
            <p:cNvSpPr/>
            <p:nvPr/>
          </p:nvSpPr>
          <p:spPr>
            <a:xfrm>
              <a:off x="4357440" y="5265000"/>
              <a:ext cx="44244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線コネクタ 36"/>
            <p:cNvSpPr/>
            <p:nvPr/>
          </p:nvSpPr>
          <p:spPr>
            <a:xfrm>
              <a:off x="4495680" y="5077080"/>
              <a:ext cx="43164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86" name="直線矢印コネクタ 38"/>
            <p:cNvCxnSpPr/>
            <p:nvPr/>
          </p:nvCxnSpPr>
          <p:spPr>
            <a:xfrm flipH="1">
              <a:off x="4432680" y="3900600"/>
              <a:ext cx="10440" cy="1372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87" name="テキスト ボックス 40"/>
            <p:cNvSpPr/>
            <p:nvPr/>
          </p:nvSpPr>
          <p:spPr>
            <a:xfrm>
              <a:off x="4233960" y="4468320"/>
              <a:ext cx="39996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正方形/長方形 150"/>
            <p:cNvSpPr/>
            <p:nvPr/>
          </p:nvSpPr>
          <p:spPr>
            <a:xfrm>
              <a:off x="4241880" y="3324240"/>
              <a:ext cx="876240" cy="2019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9" name="グループ化 152"/>
          <p:cNvGrpSpPr/>
          <p:nvPr/>
        </p:nvGrpSpPr>
        <p:grpSpPr>
          <a:xfrm>
            <a:off x="2013120" y="3316320"/>
            <a:ext cx="909360" cy="2027160"/>
            <a:chOff x="2013120" y="3316320"/>
            <a:chExt cx="909360" cy="2027160"/>
          </a:xfrm>
        </p:grpSpPr>
        <p:sp>
          <p:nvSpPr>
            <p:cNvPr id="90" name="テキスト ボックス 41"/>
            <p:cNvSpPr/>
            <p:nvPr/>
          </p:nvSpPr>
          <p:spPr>
            <a:xfrm>
              <a:off x="2231280" y="4939560"/>
              <a:ext cx="36180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b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1" name="Picture 4" descr=""/>
            <p:cNvPicPr/>
            <p:nvPr/>
          </p:nvPicPr>
          <p:blipFill>
            <a:blip r:embed="rId6"/>
            <a:srcRect l="0" t="22371" r="0" b="0"/>
            <a:stretch/>
          </p:blipFill>
          <p:spPr>
            <a:xfrm>
              <a:off x="2624400" y="3316320"/>
              <a:ext cx="236160" cy="2021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直線コネクタ 35"/>
            <p:cNvSpPr/>
            <p:nvPr/>
          </p:nvSpPr>
          <p:spPr>
            <a:xfrm>
              <a:off x="2133720" y="5257800"/>
              <a:ext cx="489600" cy="2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36"/>
            <p:cNvSpPr/>
            <p:nvPr/>
          </p:nvSpPr>
          <p:spPr>
            <a:xfrm flipV="1">
              <a:off x="2259720" y="4921560"/>
              <a:ext cx="42876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直線コネクタ 37"/>
            <p:cNvSpPr/>
            <p:nvPr/>
          </p:nvSpPr>
          <p:spPr>
            <a:xfrm>
              <a:off x="2102760" y="3707640"/>
              <a:ext cx="592920" cy="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95" name="直線矢印コネクタ 38"/>
            <p:cNvCxnSpPr/>
            <p:nvPr/>
          </p:nvCxnSpPr>
          <p:spPr>
            <a:xfrm flipH="1">
              <a:off x="2221200" y="3709800"/>
              <a:ext cx="7920" cy="1558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cxnSp>
          <p:nvCxnSpPr>
            <p:cNvPr id="96" name="直線矢印コネクタ 39"/>
            <p:cNvCxnSpPr/>
            <p:nvPr/>
          </p:nvCxnSpPr>
          <p:spPr>
            <a:xfrm flipH="1">
              <a:off x="2537640" y="4922280"/>
              <a:ext cx="5760" cy="3348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headEnd len="med" type="arrow" w="med"/>
              <a:tailEnd len="med" type="arrow" w="med"/>
            </a:ln>
          </p:spPr>
        </p:cxnSp>
        <p:sp>
          <p:nvSpPr>
            <p:cNvPr id="97" name="テキスト ボックス 40"/>
            <p:cNvSpPr/>
            <p:nvPr/>
          </p:nvSpPr>
          <p:spPr>
            <a:xfrm>
              <a:off x="2013120" y="4273200"/>
              <a:ext cx="399960" cy="30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  <a:ea typeface="Arial"/>
                </a:rPr>
                <a:t>a</a:t>
              </a:r>
              <a:r>
                <a:rPr b="1" lang="en-US" sz="1200" spc="-1" strike="noStrike" baseline="-25000">
                  <a:solidFill>
                    <a:srgbClr val="000000"/>
                  </a:solidFill>
                  <a:latin typeface="Calibri"/>
                  <a:ea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正方形/長方形 151"/>
            <p:cNvSpPr/>
            <p:nvPr/>
          </p:nvSpPr>
          <p:spPr>
            <a:xfrm>
              <a:off x="2046240" y="3324240"/>
              <a:ext cx="876240" cy="201924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99" name="直線矢印コネクタ 163"/>
          <p:cNvCxnSpPr>
            <a:stCxn id="100" idx="2"/>
          </p:cNvCxnSpPr>
          <p:nvPr/>
        </p:nvCxnSpPr>
        <p:spPr>
          <a:xfrm>
            <a:off x="2305080" y="3016080"/>
            <a:ext cx="180000" cy="308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0" name="星 6 166"/>
          <p:cNvSpPr/>
          <p:nvPr/>
        </p:nvSpPr>
        <p:spPr>
          <a:xfrm>
            <a:off x="2244600" y="2895480"/>
            <a:ext cx="120600" cy="120600"/>
          </a:xfrm>
          <a:custGeom>
            <a:avLst/>
            <a:gdLst>
              <a:gd name="textAreaLeft" fmla="*/ 19800 w 120600"/>
              <a:gd name="textAreaRight" fmla="*/ 100800 w 120600"/>
              <a:gd name="textAreaTop" fmla="*/ 29880 h 120600"/>
              <a:gd name="textAreaBottom" fmla="*/ 90720 h 120600"/>
            </a:gdLst>
            <a:ahLst/>
            <a:rect l="textAreaLeft" t="textAreaTop" r="textAreaRight" b="textAreaBottom"/>
            <a:pathLst>
              <a:path w="120650" h="120650">
                <a:moveTo>
                  <a:pt x="0" y="30163"/>
                </a:moveTo>
                <a:lnTo>
                  <a:pt x="40216" y="30162"/>
                </a:lnTo>
                <a:lnTo>
                  <a:pt x="60325" y="0"/>
                </a:lnTo>
                <a:lnTo>
                  <a:pt x="80434" y="30162"/>
                </a:lnTo>
                <a:lnTo>
                  <a:pt x="120650" y="30163"/>
                </a:lnTo>
                <a:lnTo>
                  <a:pt x="100542" y="60325"/>
                </a:lnTo>
                <a:lnTo>
                  <a:pt x="120650" y="90488"/>
                </a:lnTo>
                <a:lnTo>
                  <a:pt x="80434" y="90488"/>
                </a:lnTo>
                <a:lnTo>
                  <a:pt x="60325" y="120650"/>
                </a:lnTo>
                <a:lnTo>
                  <a:pt x="40216" y="90488"/>
                </a:lnTo>
                <a:lnTo>
                  <a:pt x="0" y="90488"/>
                </a:lnTo>
                <a:lnTo>
                  <a:pt x="20108" y="60325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1" name="直線矢印コネクタ 168"/>
          <p:cNvCxnSpPr>
            <a:stCxn id="102" idx="1"/>
          </p:cNvCxnSpPr>
          <p:nvPr/>
        </p:nvCxnSpPr>
        <p:spPr>
          <a:xfrm>
            <a:off x="2600280" y="2992680"/>
            <a:ext cx="984960" cy="332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2" name="星 6 169"/>
          <p:cNvSpPr/>
          <p:nvPr/>
        </p:nvSpPr>
        <p:spPr>
          <a:xfrm>
            <a:off x="2479680" y="2901960"/>
            <a:ext cx="120600" cy="120600"/>
          </a:xfrm>
          <a:custGeom>
            <a:avLst/>
            <a:gdLst>
              <a:gd name="textAreaLeft" fmla="*/ 19800 w 120600"/>
              <a:gd name="textAreaRight" fmla="*/ 100800 w 120600"/>
              <a:gd name="textAreaTop" fmla="*/ 29880 h 120600"/>
              <a:gd name="textAreaBottom" fmla="*/ 90720 h 120600"/>
            </a:gdLst>
            <a:ahLst/>
            <a:rect l="textAreaLeft" t="textAreaTop" r="textAreaRight" b="textAreaBottom"/>
            <a:pathLst>
              <a:path w="120650" h="120650">
                <a:moveTo>
                  <a:pt x="0" y="30163"/>
                </a:moveTo>
                <a:lnTo>
                  <a:pt x="40216" y="30162"/>
                </a:lnTo>
                <a:lnTo>
                  <a:pt x="60325" y="0"/>
                </a:lnTo>
                <a:lnTo>
                  <a:pt x="80434" y="30162"/>
                </a:lnTo>
                <a:lnTo>
                  <a:pt x="120650" y="30163"/>
                </a:lnTo>
                <a:lnTo>
                  <a:pt x="100542" y="60325"/>
                </a:lnTo>
                <a:lnTo>
                  <a:pt x="120650" y="90488"/>
                </a:lnTo>
                <a:lnTo>
                  <a:pt x="80434" y="90488"/>
                </a:lnTo>
                <a:lnTo>
                  <a:pt x="60325" y="120650"/>
                </a:lnTo>
                <a:lnTo>
                  <a:pt x="40216" y="90488"/>
                </a:lnTo>
                <a:lnTo>
                  <a:pt x="0" y="90488"/>
                </a:lnTo>
                <a:lnTo>
                  <a:pt x="20108" y="60325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3" name="直線矢印コネクタ 171"/>
          <p:cNvCxnSpPr>
            <a:stCxn id="104" idx="1"/>
          </p:cNvCxnSpPr>
          <p:nvPr/>
        </p:nvCxnSpPr>
        <p:spPr>
          <a:xfrm>
            <a:off x="3282840" y="2991240"/>
            <a:ext cx="1397520" cy="333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4" name="星 6 172"/>
          <p:cNvSpPr/>
          <p:nvPr/>
        </p:nvSpPr>
        <p:spPr>
          <a:xfrm>
            <a:off x="3162240" y="2900520"/>
            <a:ext cx="120600" cy="120600"/>
          </a:xfrm>
          <a:custGeom>
            <a:avLst/>
            <a:gdLst>
              <a:gd name="textAreaLeft" fmla="*/ 19800 w 120600"/>
              <a:gd name="textAreaRight" fmla="*/ 100800 w 120600"/>
              <a:gd name="textAreaTop" fmla="*/ 29880 h 120600"/>
              <a:gd name="textAreaBottom" fmla="*/ 90720 h 120600"/>
            </a:gdLst>
            <a:ahLst/>
            <a:rect l="textAreaLeft" t="textAreaTop" r="textAreaRight" b="textAreaBottom"/>
            <a:pathLst>
              <a:path w="120650" h="120650">
                <a:moveTo>
                  <a:pt x="0" y="30163"/>
                </a:moveTo>
                <a:lnTo>
                  <a:pt x="40216" y="30162"/>
                </a:lnTo>
                <a:lnTo>
                  <a:pt x="60325" y="0"/>
                </a:lnTo>
                <a:lnTo>
                  <a:pt x="80434" y="30162"/>
                </a:lnTo>
                <a:lnTo>
                  <a:pt x="120650" y="30163"/>
                </a:lnTo>
                <a:lnTo>
                  <a:pt x="100542" y="60325"/>
                </a:lnTo>
                <a:lnTo>
                  <a:pt x="120650" y="90488"/>
                </a:lnTo>
                <a:lnTo>
                  <a:pt x="80434" y="90488"/>
                </a:lnTo>
                <a:lnTo>
                  <a:pt x="60325" y="120650"/>
                </a:lnTo>
                <a:lnTo>
                  <a:pt x="40216" y="90488"/>
                </a:lnTo>
                <a:lnTo>
                  <a:pt x="0" y="90488"/>
                </a:lnTo>
                <a:lnTo>
                  <a:pt x="20108" y="60325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5" name="直線矢印コネクタ 174"/>
          <p:cNvCxnSpPr>
            <a:stCxn id="106" idx="1"/>
          </p:cNvCxnSpPr>
          <p:nvPr/>
        </p:nvCxnSpPr>
        <p:spPr>
          <a:xfrm>
            <a:off x="3730680" y="2991240"/>
            <a:ext cx="2107440" cy="333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6" name="星 6 175"/>
          <p:cNvSpPr/>
          <p:nvPr/>
        </p:nvSpPr>
        <p:spPr>
          <a:xfrm>
            <a:off x="3610080" y="2900520"/>
            <a:ext cx="120600" cy="120600"/>
          </a:xfrm>
          <a:custGeom>
            <a:avLst/>
            <a:gdLst>
              <a:gd name="textAreaLeft" fmla="*/ 19800 w 120600"/>
              <a:gd name="textAreaRight" fmla="*/ 100800 w 120600"/>
              <a:gd name="textAreaTop" fmla="*/ 29880 h 120600"/>
              <a:gd name="textAreaBottom" fmla="*/ 90720 h 120600"/>
            </a:gdLst>
            <a:ahLst/>
            <a:rect l="textAreaLeft" t="textAreaTop" r="textAreaRight" b="textAreaBottom"/>
            <a:pathLst>
              <a:path w="120650" h="120650">
                <a:moveTo>
                  <a:pt x="0" y="30163"/>
                </a:moveTo>
                <a:lnTo>
                  <a:pt x="40216" y="30162"/>
                </a:lnTo>
                <a:lnTo>
                  <a:pt x="60325" y="0"/>
                </a:lnTo>
                <a:lnTo>
                  <a:pt x="80434" y="30162"/>
                </a:lnTo>
                <a:lnTo>
                  <a:pt x="120650" y="30163"/>
                </a:lnTo>
                <a:lnTo>
                  <a:pt x="100542" y="60325"/>
                </a:lnTo>
                <a:lnTo>
                  <a:pt x="120650" y="90488"/>
                </a:lnTo>
                <a:lnTo>
                  <a:pt x="80434" y="90488"/>
                </a:lnTo>
                <a:lnTo>
                  <a:pt x="60325" y="120650"/>
                </a:lnTo>
                <a:lnTo>
                  <a:pt x="40216" y="90488"/>
                </a:lnTo>
                <a:lnTo>
                  <a:pt x="0" y="90488"/>
                </a:lnTo>
                <a:lnTo>
                  <a:pt x="20108" y="60325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7" name="直線矢印コネクタ 177"/>
          <p:cNvCxnSpPr>
            <a:stCxn id="108" idx="1"/>
          </p:cNvCxnSpPr>
          <p:nvPr/>
        </p:nvCxnSpPr>
        <p:spPr>
          <a:xfrm>
            <a:off x="4002120" y="2989440"/>
            <a:ext cx="2964240" cy="335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8" name="星 6 178"/>
          <p:cNvSpPr/>
          <p:nvPr/>
        </p:nvSpPr>
        <p:spPr>
          <a:xfrm>
            <a:off x="3881520" y="2898720"/>
            <a:ext cx="120600" cy="120600"/>
          </a:xfrm>
          <a:custGeom>
            <a:avLst/>
            <a:gdLst>
              <a:gd name="textAreaLeft" fmla="*/ 19800 w 120600"/>
              <a:gd name="textAreaRight" fmla="*/ 100800 w 120600"/>
              <a:gd name="textAreaTop" fmla="*/ 29880 h 120600"/>
              <a:gd name="textAreaBottom" fmla="*/ 90720 h 120600"/>
            </a:gdLst>
            <a:ahLst/>
            <a:rect l="textAreaLeft" t="textAreaTop" r="textAreaRight" b="textAreaBottom"/>
            <a:pathLst>
              <a:path w="120650" h="120650">
                <a:moveTo>
                  <a:pt x="0" y="30163"/>
                </a:moveTo>
                <a:lnTo>
                  <a:pt x="40216" y="30162"/>
                </a:lnTo>
                <a:lnTo>
                  <a:pt x="60325" y="0"/>
                </a:lnTo>
                <a:lnTo>
                  <a:pt x="80434" y="30162"/>
                </a:lnTo>
                <a:lnTo>
                  <a:pt x="120650" y="30163"/>
                </a:lnTo>
                <a:lnTo>
                  <a:pt x="100542" y="60325"/>
                </a:lnTo>
                <a:lnTo>
                  <a:pt x="120650" y="90488"/>
                </a:lnTo>
                <a:lnTo>
                  <a:pt x="80434" y="90488"/>
                </a:lnTo>
                <a:lnTo>
                  <a:pt x="60325" y="120650"/>
                </a:lnTo>
                <a:lnTo>
                  <a:pt x="40216" y="90488"/>
                </a:lnTo>
                <a:lnTo>
                  <a:pt x="0" y="90488"/>
                </a:lnTo>
                <a:lnTo>
                  <a:pt x="20108" y="60325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正方形/長方形 74"/>
          <p:cNvSpPr/>
          <p:nvPr/>
        </p:nvSpPr>
        <p:spPr>
          <a:xfrm>
            <a:off x="2200320" y="1347840"/>
            <a:ext cx="223920" cy="15192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正方形/長方形 75"/>
          <p:cNvSpPr/>
          <p:nvPr/>
        </p:nvSpPr>
        <p:spPr>
          <a:xfrm>
            <a:off x="2433600" y="1347840"/>
            <a:ext cx="223920" cy="15192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正方形/長方形 76"/>
          <p:cNvSpPr/>
          <p:nvPr/>
        </p:nvSpPr>
        <p:spPr>
          <a:xfrm>
            <a:off x="3100320" y="1347840"/>
            <a:ext cx="223920" cy="15192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正方形/長方形 77"/>
          <p:cNvSpPr/>
          <p:nvPr/>
        </p:nvSpPr>
        <p:spPr>
          <a:xfrm>
            <a:off x="3538440" y="1347840"/>
            <a:ext cx="266760" cy="15192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正方形/長方形 78"/>
          <p:cNvSpPr/>
          <p:nvPr/>
        </p:nvSpPr>
        <p:spPr>
          <a:xfrm>
            <a:off x="3800520" y="1347840"/>
            <a:ext cx="266760" cy="15192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テキスト ボックス 43"/>
          <p:cNvSpPr/>
          <p:nvPr/>
        </p:nvSpPr>
        <p:spPr>
          <a:xfrm>
            <a:off x="24120" y="-28440"/>
            <a:ext cx="6714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 S1.</a:t>
            </a:r>
            <a:r>
              <a:rPr b="1" lang="ja-JP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Quantification of mutant allele (mA%) by DNA sequenc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) Deletion or insertion type mut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25T00:10:55Z</dcterms:created>
  <dc:creator>Junnichi Soh</dc:creator>
  <dc:description/>
  <dc:language>en-US</dc:language>
  <cp:lastModifiedBy>Junnichi Soh</cp:lastModifiedBy>
  <dcterms:modified xsi:type="dcterms:W3CDTF">2009-09-26T14:48:01Z</dcterms:modified>
  <cp:revision>4</cp:revision>
  <dc:subject/>
  <dc:title>スライド 1</dc:title>
</cp:coreProperties>
</file>